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8" r:id="rId2"/>
    <p:sldId id="290" r:id="rId3"/>
    <p:sldId id="289" r:id="rId4"/>
    <p:sldId id="291" r:id="rId5"/>
    <p:sldId id="292" r:id="rId6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35" autoAdjust="0"/>
    <p:restoredTop sz="94660"/>
  </p:normalViewPr>
  <p:slideViewPr>
    <p:cSldViewPr snapToGrid="0">
      <p:cViewPr varScale="1">
        <p:scale>
          <a:sx n="50" d="100"/>
          <a:sy n="50" d="100"/>
        </p:scale>
        <p:origin x="-2400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42715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546257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31737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504610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00564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0428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44660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51576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737357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8376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510187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89AB5-B5B4-47D9-B0F0-C010E1F64CC1}" type="datetimeFigureOut">
              <a:rPr kumimoji="1" lang="ja-JP" altLang="en-US" smtClean="0"/>
              <a:pPr/>
              <a:t>2025/10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80E9C-E7D5-4536-98C4-8D1D4141B1C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97703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FBE950A7-0464-4880-A170-E731E8A247F8}"/>
              </a:ext>
            </a:extLst>
          </p:cNvPr>
          <p:cNvSpPr txBox="1"/>
          <p:nvPr/>
        </p:nvSpPr>
        <p:spPr>
          <a:xfrm>
            <a:off x="375780" y="8705589"/>
            <a:ext cx="2869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xmlns="" id="{3D2BC8C1-806D-471A-90E9-FC451B2406C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943100"/>
            <a:ext cx="6858000" cy="5735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31997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xmlns="" id="{50458FD0-F2A8-4C1B-9C58-B9C09AD94AF6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41608" y="1109604"/>
            <a:ext cx="5420112" cy="541267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07CC304D-18FB-4B69-83D6-B72E4ECB235C}"/>
              </a:ext>
            </a:extLst>
          </p:cNvPr>
          <p:cNvSpPr txBox="1"/>
          <p:nvPr/>
        </p:nvSpPr>
        <p:spPr>
          <a:xfrm>
            <a:off x="375780" y="8705589"/>
            <a:ext cx="34469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2(a)</a:t>
            </a:r>
            <a:endParaRPr kumimoji="1" lang="ja-JP" altLang="en-US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xmlns="" id="{6549D6FB-F189-45AA-9B61-FEBF47787D73}"/>
              </a:ext>
            </a:extLst>
          </p:cNvPr>
          <p:cNvCxnSpPr>
            <a:cxnSpLocks/>
          </p:cNvCxnSpPr>
          <p:nvPr/>
        </p:nvCxnSpPr>
        <p:spPr>
          <a:xfrm>
            <a:off x="2316988" y="4079760"/>
            <a:ext cx="0" cy="1639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EFECB4E2-A6F8-4EB8-A72E-C42796FFD4E9}"/>
              </a:ext>
            </a:extLst>
          </p:cNvPr>
          <p:cNvCxnSpPr/>
          <p:nvPr/>
        </p:nvCxnSpPr>
        <p:spPr>
          <a:xfrm>
            <a:off x="1378039" y="4090689"/>
            <a:ext cx="46621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349FF839-C060-4644-A5F5-0D8BF395CC21}"/>
              </a:ext>
            </a:extLst>
          </p:cNvPr>
          <p:cNvSpPr txBox="1"/>
          <p:nvPr/>
        </p:nvSpPr>
        <p:spPr>
          <a:xfrm>
            <a:off x="3119284" y="1288258"/>
            <a:ext cx="1061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365410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F74C619B-9B1B-4A52-B080-EBD56B6418C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41610" y="1109604"/>
            <a:ext cx="5420110" cy="541267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07CC304D-18FB-4B69-83D6-B72E4ECB235C}"/>
              </a:ext>
            </a:extLst>
          </p:cNvPr>
          <p:cNvSpPr txBox="1"/>
          <p:nvPr/>
        </p:nvSpPr>
        <p:spPr>
          <a:xfrm>
            <a:off x="375780" y="8705589"/>
            <a:ext cx="2900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2(b)</a:t>
            </a:r>
            <a:endParaRPr kumimoji="1" lang="ja-JP" altLang="en-US" dirty="0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xmlns="" id="{2F121B31-5015-4756-8C9B-61E520794E01}"/>
              </a:ext>
            </a:extLst>
          </p:cNvPr>
          <p:cNvCxnSpPr>
            <a:cxnSpLocks/>
          </p:cNvCxnSpPr>
          <p:nvPr/>
        </p:nvCxnSpPr>
        <p:spPr>
          <a:xfrm>
            <a:off x="2249946" y="4079760"/>
            <a:ext cx="0" cy="1647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xmlns="" id="{F2C5AD87-C5F0-4F02-ABAC-B5FF295AB80A}"/>
              </a:ext>
            </a:extLst>
          </p:cNvPr>
          <p:cNvCxnSpPr/>
          <p:nvPr/>
        </p:nvCxnSpPr>
        <p:spPr>
          <a:xfrm>
            <a:off x="1378039" y="4083315"/>
            <a:ext cx="46621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815679DC-6581-4020-8E7C-1AA4C4DF98F6}"/>
              </a:ext>
            </a:extLst>
          </p:cNvPr>
          <p:cNvSpPr txBox="1"/>
          <p:nvPr/>
        </p:nvSpPr>
        <p:spPr>
          <a:xfrm>
            <a:off x="3119284" y="1288258"/>
            <a:ext cx="1061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820066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94F3767A-C33F-42D4-A554-9B38CE3261EF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41608" y="1122304"/>
            <a:ext cx="5420112" cy="541267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07CC304D-18FB-4B69-83D6-B72E4ECB235C}"/>
              </a:ext>
            </a:extLst>
          </p:cNvPr>
          <p:cNvSpPr txBox="1"/>
          <p:nvPr/>
        </p:nvSpPr>
        <p:spPr>
          <a:xfrm>
            <a:off x="375780" y="8705589"/>
            <a:ext cx="3281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2(c)</a:t>
            </a:r>
            <a:endParaRPr kumimoji="1" lang="ja-JP" altLang="en-US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xmlns="" id="{6549D6FB-F189-45AA-9B61-FEBF47787D73}"/>
              </a:ext>
            </a:extLst>
          </p:cNvPr>
          <p:cNvCxnSpPr>
            <a:cxnSpLocks/>
          </p:cNvCxnSpPr>
          <p:nvPr/>
        </p:nvCxnSpPr>
        <p:spPr>
          <a:xfrm>
            <a:off x="3449620" y="4094508"/>
            <a:ext cx="0" cy="1639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EFECB4E2-A6F8-4EB8-A72E-C42796FFD4E9}"/>
              </a:ext>
            </a:extLst>
          </p:cNvPr>
          <p:cNvCxnSpPr/>
          <p:nvPr/>
        </p:nvCxnSpPr>
        <p:spPr>
          <a:xfrm>
            <a:off x="1378039" y="4098063"/>
            <a:ext cx="46621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AB37EDD-3A9E-4CF6-9588-D5A2F48C2805}"/>
              </a:ext>
            </a:extLst>
          </p:cNvPr>
          <p:cNvSpPr txBox="1"/>
          <p:nvPr/>
        </p:nvSpPr>
        <p:spPr>
          <a:xfrm>
            <a:off x="3119284" y="1288258"/>
            <a:ext cx="1061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780290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301A71E5-1772-4653-9E91-90B8E3AD372B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47982" y="1115663"/>
            <a:ext cx="5406364" cy="5398949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07CC304D-18FB-4B69-83D6-B72E4ECB235C}"/>
              </a:ext>
            </a:extLst>
          </p:cNvPr>
          <p:cNvSpPr txBox="1"/>
          <p:nvPr/>
        </p:nvSpPr>
        <p:spPr>
          <a:xfrm>
            <a:off x="375780" y="8705589"/>
            <a:ext cx="3243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2(d)</a:t>
            </a:r>
            <a:endParaRPr kumimoji="1" lang="ja-JP" altLang="en-US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xmlns="" id="{6549D6FB-F189-45AA-9B61-FEBF47787D73}"/>
              </a:ext>
            </a:extLst>
          </p:cNvPr>
          <p:cNvCxnSpPr>
            <a:cxnSpLocks/>
          </p:cNvCxnSpPr>
          <p:nvPr/>
        </p:nvCxnSpPr>
        <p:spPr>
          <a:xfrm>
            <a:off x="2230780" y="4079760"/>
            <a:ext cx="0" cy="16397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EFECB4E2-A6F8-4EB8-A72E-C42796FFD4E9}"/>
              </a:ext>
            </a:extLst>
          </p:cNvPr>
          <p:cNvCxnSpPr/>
          <p:nvPr/>
        </p:nvCxnSpPr>
        <p:spPr>
          <a:xfrm>
            <a:off x="1378039" y="4083315"/>
            <a:ext cx="46621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48896A29-1E2D-4235-8382-639D0CEE7798}"/>
              </a:ext>
            </a:extLst>
          </p:cNvPr>
          <p:cNvSpPr txBox="1"/>
          <p:nvPr/>
        </p:nvSpPr>
        <p:spPr>
          <a:xfrm>
            <a:off x="3119284" y="1288258"/>
            <a:ext cx="1061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19725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</TotalTime>
  <Words>23</Words>
  <Application>Microsoft Office PowerPoint</Application>
  <PresentationFormat>A4 Paper (210x297 mm)</PresentationFormat>
  <Paragraphs>9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テーマ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N</dc:creator>
  <cp:lastModifiedBy>Sandhya R</cp:lastModifiedBy>
  <cp:revision>64</cp:revision>
  <cp:lastPrinted>2015-10-08T02:34:27Z</cp:lastPrinted>
  <dcterms:created xsi:type="dcterms:W3CDTF">2015-09-06T00:22:42Z</dcterms:created>
  <dcterms:modified xsi:type="dcterms:W3CDTF">2025-10-08T06:56:14Z</dcterms:modified>
</cp:coreProperties>
</file>